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150" d="100"/>
          <a:sy n="150" d="100"/>
        </p:scale>
        <p:origin x="1512" y="-34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F80AF-D40A-4974-ABEC-5E9277EA3525}" type="datetimeFigureOut">
              <a:rPr lang="en-NZ" smtClean="0"/>
              <a:t>5/12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36C7-A4AA-4220-831E-DC5DA96E1EC7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39183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F80AF-D40A-4974-ABEC-5E9277EA3525}" type="datetimeFigureOut">
              <a:rPr lang="en-NZ" smtClean="0"/>
              <a:t>5/12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36C7-A4AA-4220-831E-DC5DA96E1EC7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964112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F80AF-D40A-4974-ABEC-5E9277EA3525}" type="datetimeFigureOut">
              <a:rPr lang="en-NZ" smtClean="0"/>
              <a:t>5/12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36C7-A4AA-4220-831E-DC5DA96E1EC7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94748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F80AF-D40A-4974-ABEC-5E9277EA3525}" type="datetimeFigureOut">
              <a:rPr lang="en-NZ" smtClean="0"/>
              <a:t>5/12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36C7-A4AA-4220-831E-DC5DA96E1EC7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28740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F80AF-D40A-4974-ABEC-5E9277EA3525}" type="datetimeFigureOut">
              <a:rPr lang="en-NZ" smtClean="0"/>
              <a:t>5/12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36C7-A4AA-4220-831E-DC5DA96E1EC7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678490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F80AF-D40A-4974-ABEC-5E9277EA3525}" type="datetimeFigureOut">
              <a:rPr lang="en-NZ" smtClean="0"/>
              <a:t>5/12/2018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36C7-A4AA-4220-831E-DC5DA96E1EC7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840977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F80AF-D40A-4974-ABEC-5E9277EA3525}" type="datetimeFigureOut">
              <a:rPr lang="en-NZ" smtClean="0"/>
              <a:t>5/12/2018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36C7-A4AA-4220-831E-DC5DA96E1EC7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495563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F80AF-D40A-4974-ABEC-5E9277EA3525}" type="datetimeFigureOut">
              <a:rPr lang="en-NZ" smtClean="0"/>
              <a:t>5/12/2018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36C7-A4AA-4220-831E-DC5DA96E1EC7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192577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F80AF-D40A-4974-ABEC-5E9277EA3525}" type="datetimeFigureOut">
              <a:rPr lang="en-NZ" smtClean="0"/>
              <a:t>5/12/2018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36C7-A4AA-4220-831E-DC5DA96E1EC7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58452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F80AF-D40A-4974-ABEC-5E9277EA3525}" type="datetimeFigureOut">
              <a:rPr lang="en-NZ" smtClean="0"/>
              <a:t>5/12/2018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36C7-A4AA-4220-831E-DC5DA96E1EC7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404983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F80AF-D40A-4974-ABEC-5E9277EA3525}" type="datetimeFigureOut">
              <a:rPr lang="en-NZ" smtClean="0"/>
              <a:t>5/12/2018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36C7-A4AA-4220-831E-DC5DA96E1EC7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04022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2F80AF-D40A-4974-ABEC-5E9277EA3525}" type="datetimeFigureOut">
              <a:rPr lang="en-NZ" smtClean="0"/>
              <a:t>5/12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D736C7-A4AA-4220-831E-DC5DA96E1EC7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51436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333" y="4598742"/>
            <a:ext cx="2160000" cy="5307258"/>
          </a:xfrm>
          <a:prstGeom prst="rect">
            <a:avLst/>
          </a:prstGeom>
        </p:spPr>
      </p:pic>
      <p:sp>
        <p:nvSpPr>
          <p:cNvPr id="21" name="Rectangle 20"/>
          <p:cNvSpPr/>
          <p:nvPr/>
        </p:nvSpPr>
        <p:spPr>
          <a:xfrm rot="16200000">
            <a:off x="-2585" y="6975903"/>
            <a:ext cx="112883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N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F Group III </a:t>
            </a: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3333" y="242481"/>
            <a:ext cx="2160000" cy="188937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3333" y="2150617"/>
            <a:ext cx="2160000" cy="2364673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 rot="16200000">
            <a:off x="23063" y="3380177"/>
            <a:ext cx="10775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N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F Group </a:t>
            </a:r>
            <a:r>
              <a:rPr lang="en-N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 </a:t>
            </a:r>
            <a:endParaRPr lang="en-NZ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angle 24"/>
          <p:cNvSpPr/>
          <p:nvPr/>
        </p:nvSpPr>
        <p:spPr>
          <a:xfrm rot="16200000">
            <a:off x="48712" y="1129182"/>
            <a:ext cx="102624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N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F Group </a:t>
            </a:r>
            <a:r>
              <a:rPr lang="en-N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 </a:t>
            </a:r>
            <a:endParaRPr lang="en-NZ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72467" y="242481"/>
            <a:ext cx="2160000" cy="1556662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72467" y="1938843"/>
            <a:ext cx="2160000" cy="3159667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72467" y="5251865"/>
            <a:ext cx="2160000" cy="1862537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72467" y="7360777"/>
            <a:ext cx="2160000" cy="1955290"/>
          </a:xfrm>
          <a:prstGeom prst="rect">
            <a:avLst/>
          </a:prstGeom>
        </p:spPr>
      </p:pic>
      <p:sp>
        <p:nvSpPr>
          <p:cNvPr id="30" name="Rectangle 29"/>
          <p:cNvSpPr/>
          <p:nvPr/>
        </p:nvSpPr>
        <p:spPr>
          <a:xfrm rot="16200000">
            <a:off x="3366921" y="882312"/>
            <a:ext cx="11340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N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F Group </a:t>
            </a:r>
            <a:r>
              <a:rPr lang="en-N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V </a:t>
            </a:r>
            <a:endParaRPr lang="en-NZ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/>
          <p:cNvSpPr/>
          <p:nvPr/>
        </p:nvSpPr>
        <p:spPr>
          <a:xfrm rot="16200000">
            <a:off x="3411804" y="3600112"/>
            <a:ext cx="10443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N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F Group V</a:t>
            </a:r>
          </a:p>
        </p:txBody>
      </p:sp>
      <p:sp>
        <p:nvSpPr>
          <p:cNvPr id="32" name="Rectangle 31"/>
          <p:cNvSpPr/>
          <p:nvPr/>
        </p:nvSpPr>
        <p:spPr>
          <a:xfrm rot="16200000">
            <a:off x="3366921" y="6317911"/>
            <a:ext cx="11340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N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F Group </a:t>
            </a:r>
            <a:r>
              <a:rPr lang="en-N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 </a:t>
            </a:r>
            <a:endParaRPr lang="en-NZ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32"/>
          <p:cNvSpPr/>
          <p:nvPr/>
        </p:nvSpPr>
        <p:spPr>
          <a:xfrm rot="16200000">
            <a:off x="3341273" y="8351560"/>
            <a:ext cx="118538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N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F Group </a:t>
            </a:r>
            <a:r>
              <a:rPr lang="en-N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I </a:t>
            </a:r>
            <a:endParaRPr lang="en-NZ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42077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5499" y="414866"/>
            <a:ext cx="2160000" cy="379113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8829" y="414866"/>
            <a:ext cx="2160000" cy="6128653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 rot="16200000">
            <a:off x="-141343" y="2086226"/>
            <a:ext cx="12366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N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F Group </a:t>
            </a:r>
            <a:r>
              <a:rPr lang="en-N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II </a:t>
            </a:r>
            <a:endParaRPr lang="en-NZ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 rot="16200000">
            <a:off x="3029640" y="3297263"/>
            <a:ext cx="10983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N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F Group </a:t>
            </a:r>
            <a:r>
              <a:rPr lang="en-N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X</a:t>
            </a:r>
            <a:endParaRPr lang="en-NZ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 rot="16200000">
            <a:off x="-65778" y="7208560"/>
            <a:ext cx="10855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N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F Group </a:t>
            </a:r>
            <a:r>
              <a:rPr lang="en-N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 </a:t>
            </a:r>
            <a:endParaRPr lang="en-NZ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78829" y="7214486"/>
            <a:ext cx="2160000" cy="1636083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 rot="16200000">
            <a:off x="3021167" y="7666388"/>
            <a:ext cx="8162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N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P/PHL</a:t>
            </a:r>
            <a:endParaRPr lang="en-NZ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3999" y="5156939"/>
            <a:ext cx="2160000" cy="36936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12033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5694" y="262467"/>
            <a:ext cx="2160000" cy="418371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 rot="16200000">
            <a:off x="82093" y="2035729"/>
            <a:ext cx="111761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N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2 like genes</a:t>
            </a:r>
            <a:endParaRPr lang="en-NZ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7508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</TotalTime>
  <Words>34</Words>
  <Application>Microsoft Office PowerPoint</Application>
  <PresentationFormat>A4 Paper (210x297 mm)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Plant &amp; Food Researc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Schaffer</dc:creator>
  <cp:lastModifiedBy>Robert Schaffer</cp:lastModifiedBy>
  <cp:revision>9</cp:revision>
  <cp:lastPrinted>2018-11-23T01:01:02Z</cp:lastPrinted>
  <dcterms:created xsi:type="dcterms:W3CDTF">2018-11-22T07:18:29Z</dcterms:created>
  <dcterms:modified xsi:type="dcterms:W3CDTF">2018-12-05T00:04:10Z</dcterms:modified>
</cp:coreProperties>
</file>